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3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01ABB1-4F20-4FBE-8F36-53A233D1D3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72EBAB6-A08D-4D69-AA8D-57CF4E9CDF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BF7804-EFCE-4B7D-B7A7-269078772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F02028-CAB8-45F3-AAD1-D9EB8DE2F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CC5F89-ED9B-4CEA-BB58-CF9709771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6692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84F2C9-8C0F-41BA-A817-43CECE4D3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F721F6-62C5-48B2-88C7-211054FF27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48B9AE-9251-49A9-BAE3-B8BC6FF0A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177FC6-70BB-4E85-8AF1-BED2B8F92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DD835E-DBAB-4928-A11C-2A8283860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4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FE28780-8FD8-4D43-B81E-CDB1CE1C99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00DA32F-D55F-41F4-93A3-22E15996A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7F2FFB-DD3A-4ACC-B15B-392B94675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01E68A-D57F-4EF4-8E42-0778DE64F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D320B7-D05B-4734-8F9D-069FA71F9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686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8FC600-AFF9-48EE-9470-CD13592517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0A74BF-F227-41C3-A185-BAAC4E878F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C6AF6A-E53C-41EF-8AC1-2433177A2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DECC9B-B7F3-4736-AC18-75998CA53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9768A47-7F0B-400A-970F-F705B6EE5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805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64CA7B-1F35-4220-88E8-C08084A9C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18C044D-F73E-4B38-855F-924E20BC32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B79D76-39E0-4DB2-B808-E75CA890F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72E13D-E135-4BF2-B7EB-791C6E267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412F71-262A-4BA7-B538-3E06FED00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954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24333C-4B8A-4719-A973-59B323517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FEA8C6-7B12-4BA0-9BDD-ABF4F6FEA9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816EC4B-24CE-43CE-816B-8C6207EA61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85AD23-A1A6-4EF0-A934-39F7248A9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06246C-C4DD-4772-97CB-35F5C6D13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A1D0AA-8A90-497D-82C1-CDC293087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402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B8C27-222B-46D6-9A68-BEF415DDC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21049C-AE68-47EB-B137-82F71574E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56E32ED-6DF2-45B5-9CDD-B9322CF516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41F7E5F-A8D6-4FDD-BCA1-0E5D843B77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A20FEF7-06C8-416E-BD21-77E70E8E1D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516183B-558E-4415-982F-0FEF0D6C2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D2515BC-12D4-47DF-B8EE-51A218EFB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4498165-13B4-4CC6-BFA3-449BD9C42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1286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5B9C72-1C6E-4667-BDF5-F9F7D8520E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858460-7266-4CF0-95AC-BBF968FF3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9BCB909-ADAF-42E3-8656-B3B99F722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850451D-CF52-4FC5-AABC-D6BEF2F0B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4758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FC0562A-5A24-4640-A5BC-F96FC48F3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D2A50EE-0923-4418-974F-F6A049E3B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B895D20-BBD6-49A8-87AB-86EA22A71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941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DF1125-D126-4869-85AC-2CA1C3FE9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149A9B-ADCC-463C-97DB-07A035D771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52B404-94B6-4EA0-87BA-5D1AC4CCF9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C65DDC-F37B-4E1B-BB4D-9265FA393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65074D-B957-43D2-B6EA-396FEFE25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68078C-846F-4687-A327-EDD24E1FB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6397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19862A-093A-441A-ACFF-3D7A98ECB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21A802E-1E06-4A5C-A579-915088A0C6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5802F6-09C1-45B6-8884-C756ABB5C7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54CF6B-F5B4-4E8C-99D1-70D3F4292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F9BAAA-04FB-4799-BBFD-9FF17A8A8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BE45F7-40A0-49CD-8B51-60A0145D9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83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BD13A3F-85E6-4E7B-B6DD-7DA9516461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646ACD7-2E71-4F83-A95A-031BDC68C7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B2820F-E411-473E-B116-D31E04B46A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DD11E-7369-4E5C-B4CD-081E75DD76A5}" type="datetimeFigureOut">
              <a:rPr lang="zh-CN" altLang="en-US" smtClean="0"/>
              <a:t>2023/12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510592-5995-416E-96BA-FD30A8BC92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9D8DC8-3D42-4152-8F7D-872D6F0067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13FC6-64DA-4C2D-A5A3-02B44367B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025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>
            <a:extLst>
              <a:ext uri="{FF2B5EF4-FFF2-40B4-BE49-F238E27FC236}">
                <a16:creationId xmlns:a16="http://schemas.microsoft.com/office/drawing/2014/main" id="{39B779CB-D3EE-4DD1-9190-A7687BF03BFF}"/>
              </a:ext>
            </a:extLst>
          </p:cNvPr>
          <p:cNvGrpSpPr/>
          <p:nvPr/>
        </p:nvGrpSpPr>
        <p:grpSpPr>
          <a:xfrm>
            <a:off x="3644349" y="821635"/>
            <a:ext cx="5791176" cy="5214730"/>
            <a:chOff x="4625009" y="225287"/>
            <a:chExt cx="5791176" cy="5214730"/>
          </a:xfrm>
        </p:grpSpPr>
        <p:sp>
          <p:nvSpPr>
            <p:cNvPr id="4" name="流程图: 过程 3">
              <a:extLst>
                <a:ext uri="{FF2B5EF4-FFF2-40B4-BE49-F238E27FC236}">
                  <a16:creationId xmlns:a16="http://schemas.microsoft.com/office/drawing/2014/main" id="{8D312E04-A1DC-4E29-ADA2-8FB59B656AB3}"/>
                </a:ext>
              </a:extLst>
            </p:cNvPr>
            <p:cNvSpPr/>
            <p:nvPr/>
          </p:nvSpPr>
          <p:spPr>
            <a:xfrm>
              <a:off x="4625009" y="225287"/>
              <a:ext cx="3034748" cy="755374"/>
            </a:xfrm>
            <a:prstGeom prst="flowChartProcess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16 lactating women were initially recruited with their basic information.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>
              <a:extLst>
                <a:ext uri="{FF2B5EF4-FFF2-40B4-BE49-F238E27FC236}">
                  <a16:creationId xmlns:a16="http://schemas.microsoft.com/office/drawing/2014/main" id="{B3A4C836-76CC-4328-BA57-C10A34415BDD}"/>
                </a:ext>
              </a:extLst>
            </p:cNvPr>
            <p:cNvCxnSpPr>
              <a:cxnSpLocks/>
              <a:stCxn id="4" idx="2"/>
            </p:cNvCxnSpPr>
            <p:nvPr/>
          </p:nvCxnSpPr>
          <p:spPr>
            <a:xfrm>
              <a:off x="6142383" y="980661"/>
              <a:ext cx="0" cy="144448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8">
              <a:extLst>
                <a:ext uri="{FF2B5EF4-FFF2-40B4-BE49-F238E27FC236}">
                  <a16:creationId xmlns:a16="http://schemas.microsoft.com/office/drawing/2014/main" id="{3BFF0904-8EF6-477E-BE9E-FFC5132EA67D}"/>
                </a:ext>
              </a:extLst>
            </p:cNvPr>
            <p:cNvCxnSpPr/>
            <p:nvPr/>
          </p:nvCxnSpPr>
          <p:spPr>
            <a:xfrm>
              <a:off x="6142383" y="1643270"/>
              <a:ext cx="151737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流程图: 过程 9">
              <a:extLst>
                <a:ext uri="{FF2B5EF4-FFF2-40B4-BE49-F238E27FC236}">
                  <a16:creationId xmlns:a16="http://schemas.microsoft.com/office/drawing/2014/main" id="{76ABAB0F-5CD3-46BE-B47A-BCC2050C4165}"/>
                </a:ext>
              </a:extLst>
            </p:cNvPr>
            <p:cNvSpPr/>
            <p:nvPr/>
          </p:nvSpPr>
          <p:spPr>
            <a:xfrm>
              <a:off x="7673009" y="1152940"/>
              <a:ext cx="2743176" cy="1046922"/>
            </a:xfrm>
            <a:prstGeom prst="flowChartProcess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 were excluded due to maternal age greater than 35 years (n=6) or over 49 days postpartum (n=3).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流程图: 过程 10">
              <a:extLst>
                <a:ext uri="{FF2B5EF4-FFF2-40B4-BE49-F238E27FC236}">
                  <a16:creationId xmlns:a16="http://schemas.microsoft.com/office/drawing/2014/main" id="{BED9A53F-90D8-41B0-95D5-FE477BA42628}"/>
                </a:ext>
              </a:extLst>
            </p:cNvPr>
            <p:cNvSpPr/>
            <p:nvPr/>
          </p:nvSpPr>
          <p:spPr>
            <a:xfrm>
              <a:off x="4625009" y="2478156"/>
              <a:ext cx="3034748" cy="755374"/>
            </a:xfrm>
            <a:prstGeom prst="flowChartProcess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7 lactating women had plasma and breast milk retinol records.</a:t>
              </a:r>
              <a:endParaRPr lang="zh-CN" alt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BA12E96E-4952-485A-A605-391C861A4429}"/>
                </a:ext>
              </a:extLst>
            </p:cNvPr>
            <p:cNvCxnSpPr>
              <a:cxnSpLocks/>
            </p:cNvCxnSpPr>
            <p:nvPr/>
          </p:nvCxnSpPr>
          <p:spPr>
            <a:xfrm>
              <a:off x="6142383" y="3226904"/>
              <a:ext cx="0" cy="144448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B41681F2-7633-4678-B7D1-35D28F03A4D7}"/>
                </a:ext>
              </a:extLst>
            </p:cNvPr>
            <p:cNvCxnSpPr/>
            <p:nvPr/>
          </p:nvCxnSpPr>
          <p:spPr>
            <a:xfrm>
              <a:off x="6142383" y="3876261"/>
              <a:ext cx="151737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流程图: 过程 13">
              <a:extLst>
                <a:ext uri="{FF2B5EF4-FFF2-40B4-BE49-F238E27FC236}">
                  <a16:creationId xmlns:a16="http://schemas.microsoft.com/office/drawing/2014/main" id="{DFFE955A-07BD-4987-BE9F-11786D56ECB3}"/>
                </a:ext>
              </a:extLst>
            </p:cNvPr>
            <p:cNvSpPr/>
            <p:nvPr/>
          </p:nvSpPr>
          <p:spPr>
            <a:xfrm>
              <a:off x="7673009" y="3574775"/>
              <a:ext cx="2743176" cy="602972"/>
            </a:xfrm>
            <a:prstGeom prst="flowChartProcess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 were excluded due to retinol concentration outliers.</a:t>
              </a:r>
              <a:endParaRPr lang="zh-CN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zh-CN" altLang="en-US" dirty="0"/>
            </a:p>
          </p:txBody>
        </p:sp>
        <p:sp>
          <p:nvSpPr>
            <p:cNvPr id="15" name="流程图: 过程 14">
              <a:extLst>
                <a:ext uri="{FF2B5EF4-FFF2-40B4-BE49-F238E27FC236}">
                  <a16:creationId xmlns:a16="http://schemas.microsoft.com/office/drawing/2014/main" id="{069B7540-6606-4EF7-A1EA-6F4DC3EB9F4A}"/>
                </a:ext>
              </a:extLst>
            </p:cNvPr>
            <p:cNvSpPr/>
            <p:nvPr/>
          </p:nvSpPr>
          <p:spPr>
            <a:xfrm>
              <a:off x="4625009" y="4684643"/>
              <a:ext cx="3034748" cy="755374"/>
            </a:xfrm>
            <a:prstGeom prst="flowChartProcess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3 women were included in the present analysis.</a:t>
              </a:r>
              <a:endParaRPr lang="zh-CN" altLang="zh-C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zh-CN" altLang="en-US" dirty="0"/>
            </a:p>
          </p:txBody>
        </p:sp>
      </p:grpSp>
      <p:sp>
        <p:nvSpPr>
          <p:cNvPr id="17" name="矩形 16">
            <a:extLst>
              <a:ext uri="{FF2B5EF4-FFF2-40B4-BE49-F238E27FC236}">
                <a16:creationId xmlns:a16="http://schemas.microsoft.com/office/drawing/2014/main" id="{162DEB05-7C38-4ABC-90FB-961902A03B9D}"/>
              </a:ext>
            </a:extLst>
          </p:cNvPr>
          <p:cNvSpPr/>
          <p:nvPr/>
        </p:nvSpPr>
        <p:spPr>
          <a:xfrm>
            <a:off x="3644349" y="6349520"/>
            <a:ext cx="51782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low Chart of this study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675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</TotalTime>
  <Words>76</Words>
  <Application>Microsoft Macintosh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秦婧</dc:creator>
  <cp:lastModifiedBy>秦 婧</cp:lastModifiedBy>
  <cp:revision>8</cp:revision>
  <dcterms:created xsi:type="dcterms:W3CDTF">2021-07-08T02:46:58Z</dcterms:created>
  <dcterms:modified xsi:type="dcterms:W3CDTF">2023-12-12T10:10:23Z</dcterms:modified>
</cp:coreProperties>
</file>